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73" autoAdjust="0"/>
  </p:normalViewPr>
  <p:slideViewPr>
    <p:cSldViewPr>
      <p:cViewPr varScale="1">
        <p:scale>
          <a:sx n="109" d="100"/>
          <a:sy n="109" d="100"/>
        </p:scale>
        <p:origin x="-172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4BE308-CA68-4A6B-9F5C-D7E2CC05CAD1}" type="datetimeFigureOut">
              <a:rPr lang="de-DE" smtClean="0"/>
              <a:pPr/>
              <a:t>21.01.2017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E62841-697E-4FAC-93A7-F37878A783B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3586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E62841-697E-4FAC-93A7-F37878A783B3}" type="slidenum">
              <a:rPr lang="de-DE" smtClean="0"/>
              <a:pPr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5293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>
          <a:blip/>
          <a:tile sx="8004" sy="500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12"/>
          <p:cNvSpPr/>
          <p:nvPr/>
        </p:nvSpPr>
        <p:spPr>
          <a:xfrm>
            <a:off x="65315" y="69750"/>
            <a:ext cx="9013368" cy="6692200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blipFill>
            <a:blip>
              <a:alphaModFix/>
            </a:blip>
            <a:tile sx="8004" sy="500" algn="tl"/>
          </a:blip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Subtitle 8"/>
          <p:cNvSpPr txBox="1">
            <a:spLocks noGrp="1"/>
          </p:cNvSpPr>
          <p:nvPr>
            <p:ph type="subTitle" idx="1"/>
          </p:nvPr>
        </p:nvSpPr>
        <p:spPr>
          <a:xfrm>
            <a:off x="1295403" y="3200400"/>
            <a:ext cx="6400800" cy="1600200"/>
          </a:xfrm>
        </p:spPr>
        <p:txBody>
          <a:bodyPr anchorCtr="1"/>
          <a:lstStyle>
            <a:lvl1pPr marL="0" indent="0" algn="ctr">
              <a:buNone/>
              <a:defRPr>
                <a:solidFill>
                  <a:srgbClr val="696464"/>
                </a:solidFill>
              </a:defRPr>
            </a:lvl1pPr>
          </a:lstStyle>
          <a:p>
            <a:pPr lvl="0"/>
            <a:r>
              <a:rPr lang="en-US"/>
              <a:t>Click to edit Master subtitle style</a:t>
            </a:r>
          </a:p>
        </p:txBody>
      </p:sp>
      <p:sp>
        <p:nvSpPr>
          <p:cNvPr id="5" name="Date Placeholder 27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7D5F169-7250-407F-A2E4-EA0691443D84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6" name="Footer Placeholder 16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2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E511270-A0DB-4AAD-9361-1232479CF50B}" type="slidenum">
              <a:rPr/>
              <a:pPr lvl="0"/>
              <a:t>‹#›</a:t>
            </a:fld>
            <a:endParaRPr lang="de-DE"/>
          </a:p>
        </p:txBody>
      </p:sp>
      <p:sp>
        <p:nvSpPr>
          <p:cNvPr id="8" name="Rectangle 6"/>
          <p:cNvSpPr/>
          <p:nvPr/>
        </p:nvSpPr>
        <p:spPr>
          <a:xfrm>
            <a:off x="62929" y="1449305"/>
            <a:ext cx="9021534" cy="1527349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9"/>
          <p:cNvSpPr/>
          <p:nvPr/>
        </p:nvSpPr>
        <p:spPr>
          <a:xfrm>
            <a:off x="62929" y="1396718"/>
            <a:ext cx="9021534" cy="120581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Rectangle 10"/>
          <p:cNvSpPr/>
          <p:nvPr/>
        </p:nvSpPr>
        <p:spPr>
          <a:xfrm>
            <a:off x="62929" y="2976646"/>
            <a:ext cx="9021534" cy="110532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1" name="Title 7"/>
          <p:cNvSpPr txBox="1">
            <a:spLocks noGrp="1"/>
          </p:cNvSpPr>
          <p:nvPr>
            <p:ph type="ctrTitle"/>
          </p:nvPr>
        </p:nvSpPr>
        <p:spPr>
          <a:xfrm>
            <a:off x="457200" y="1505934"/>
            <a:ext cx="8229600" cy="1470026"/>
          </a:xfrm>
        </p:spPr>
        <p:txBody>
          <a:bodyPr anchor="ctr" anchorCtr="1"/>
          <a:lstStyle>
            <a:lvl1pPr algn="ctr">
              <a:defRPr>
                <a:solidFill>
                  <a:srgbClr val="FFFFFF"/>
                </a:solidFill>
              </a:defRPr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7202126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4727E3C-631C-4AB4-A0E5-C066F6EE394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CF92128-E436-40BF-8973-9F8E83BD4EFC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10012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 txBox="1">
            <a:spLocks noGrp="1"/>
          </p:cNvSpPr>
          <p:nvPr>
            <p:ph type="title" orient="vert"/>
          </p:nvPr>
        </p:nvSpPr>
        <p:spPr>
          <a:xfrm>
            <a:off x="6629400" y="274640"/>
            <a:ext cx="2011680" cy="5851529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>
          <a:xfrm>
            <a:off x="914400" y="274640"/>
            <a:ext cx="5562596" cy="5851529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60B198F-4474-4BA9-8712-189BFADE6B5D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04746E1-5A69-40C7-8C30-1AA7D0DE089F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37371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1ECE5AF-9A72-4802-AABC-CD7FD97A2EE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161E25C-BDA8-4363-884F-6D35F2C7EFD0}" type="slidenum">
              <a:rPr/>
              <a:pPr lvl="0"/>
              <a:t>‹#›</a:t>
            </a:fld>
            <a:endParaRPr lang="de-DE"/>
          </a:p>
        </p:txBody>
      </p:sp>
      <p:sp>
        <p:nvSpPr>
          <p:cNvPr id="6" name="Content Placeholder 7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9952189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blipFill>
          <a:blip/>
          <a:tile sx="8004" sy="500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0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9"/>
          <p:cNvSpPr/>
          <p:nvPr/>
        </p:nvSpPr>
        <p:spPr>
          <a:xfrm>
            <a:off x="65315" y="69750"/>
            <a:ext cx="9013368" cy="6692200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blipFill>
            <a:blip>
              <a:alphaModFix/>
            </a:blip>
            <a:tile sx="8004" sy="500" algn="tl"/>
          </a:blip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xfrm>
            <a:off x="722311" y="952503"/>
            <a:ext cx="7772400" cy="1362071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2"/>
          <p:cNvSpPr txBox="1">
            <a:spLocks noGrp="1"/>
          </p:cNvSpPr>
          <p:nvPr>
            <p:ph type="body" idx="1"/>
          </p:nvPr>
        </p:nvSpPr>
        <p:spPr>
          <a:xfrm>
            <a:off x="722311" y="2547939"/>
            <a:ext cx="7772400" cy="1338260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3C3775B-58D3-40C3-9283-85FBAF4B20AA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4"/>
          <p:cNvSpPr txBox="1">
            <a:spLocks noGrp="1"/>
          </p:cNvSpPr>
          <p:nvPr>
            <p:ph type="ftr" sz="quarter" idx="9"/>
          </p:nvPr>
        </p:nvSpPr>
        <p:spPr>
          <a:xfrm>
            <a:off x="800100" y="6172200"/>
            <a:ext cx="4000500" cy="457200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8" name="Rectangle 6"/>
          <p:cNvSpPr/>
          <p:nvPr/>
        </p:nvSpPr>
        <p:spPr>
          <a:xfrm flipV="1">
            <a:off x="69412" y="2376827"/>
            <a:ext cx="9013515" cy="91440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7"/>
          <p:cNvSpPr/>
          <p:nvPr/>
        </p:nvSpPr>
        <p:spPr>
          <a:xfrm>
            <a:off x="69146" y="2341476"/>
            <a:ext cx="9013780" cy="45720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Rectangle 8"/>
          <p:cNvSpPr/>
          <p:nvPr/>
        </p:nvSpPr>
        <p:spPr>
          <a:xfrm>
            <a:off x="68305" y="2468880"/>
            <a:ext cx="9014621" cy="45720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1" name="Slide Number Placeholder 5"/>
          <p:cNvSpPr txBox="1">
            <a:spLocks noGrp="1"/>
          </p:cNvSpPr>
          <p:nvPr>
            <p:ph type="sldNum" sz="quarter" idx="8"/>
          </p:nvPr>
        </p:nvSpPr>
        <p:spPr>
          <a:xfrm>
            <a:off x="146304" y="6208776"/>
            <a:ext cx="457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fld id="{F890AC72-C3E8-4D3D-982D-A8E7A1AC8729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39227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1300614-3240-4435-87DE-31274C0B51D8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EB5FD13-67B2-481D-B1BB-2DB515FB124E}" type="slidenum">
              <a:rPr/>
              <a:pPr lvl="0"/>
              <a:t>‹#›</a:t>
            </a:fld>
            <a:endParaRPr lang="de-DE"/>
          </a:p>
        </p:txBody>
      </p:sp>
      <p:sp>
        <p:nvSpPr>
          <p:cNvPr id="6" name="Content Placeholder 8"/>
          <p:cNvSpPr txBox="1">
            <a:spLocks noGrp="1"/>
          </p:cNvSpPr>
          <p:nvPr>
            <p:ph idx="1"/>
          </p:nvPr>
        </p:nvSpPr>
        <p:spPr>
          <a:xfrm>
            <a:off x="914400" y="1447796"/>
            <a:ext cx="3749039" cy="4572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Content Placeholder 10"/>
          <p:cNvSpPr txBox="1">
            <a:spLocks noGrp="1"/>
          </p:cNvSpPr>
          <p:nvPr>
            <p:ph idx="2"/>
          </p:nvPr>
        </p:nvSpPr>
        <p:spPr>
          <a:xfrm>
            <a:off x="4933946" y="1447796"/>
            <a:ext cx="3749039" cy="4572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065455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914400" y="273048"/>
            <a:ext cx="7772400" cy="1143000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914400" y="1447796"/>
            <a:ext cx="3733796" cy="761996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D34817"/>
                </a:solidFill>
                <a:latin typeface="Franklin Gothic Book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3"/>
          </p:nvPr>
        </p:nvSpPr>
        <p:spPr>
          <a:xfrm>
            <a:off x="4953003" y="1447796"/>
            <a:ext cx="3733796" cy="761996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rgbClr val="D34817"/>
                </a:solidFill>
                <a:latin typeface="Franklin Gothic Book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088F3A7-F488-4862-91B3-99FE4BB230D2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6" name="Footer Placeholder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52A46C0-9D38-42CB-8A5E-467504A116F8}" type="slidenum">
              <a:rPr/>
              <a:pPr lvl="0"/>
              <a:t>‹#›</a:t>
            </a:fld>
            <a:endParaRPr lang="de-DE"/>
          </a:p>
        </p:txBody>
      </p:sp>
      <p:sp>
        <p:nvSpPr>
          <p:cNvPr id="8" name="Content Placeholder 10"/>
          <p:cNvSpPr txBox="1">
            <a:spLocks noGrp="1"/>
          </p:cNvSpPr>
          <p:nvPr>
            <p:ph idx="2"/>
          </p:nvPr>
        </p:nvSpPr>
        <p:spPr>
          <a:xfrm>
            <a:off x="914400" y="2247896"/>
            <a:ext cx="3733796" cy="38862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9" name="Content Placeholder 12"/>
          <p:cNvSpPr txBox="1">
            <a:spLocks noGrp="1"/>
          </p:cNvSpPr>
          <p:nvPr>
            <p:ph idx="4"/>
          </p:nvPr>
        </p:nvSpPr>
        <p:spPr>
          <a:xfrm>
            <a:off x="4953003" y="2247896"/>
            <a:ext cx="3733796" cy="38862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228562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142A67C-F73A-4B77-B103-94E0DFACC5A6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1176507-1D35-4C1D-8B92-25C07D15E817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30832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975BEF2-B91B-493A-8CB9-8A48C6B0EBAB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3" name="Footer Placeholder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4" name="Slide Number Placehold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39B3995-1CF2-4A8D-88A6-0A28FB4C29AC}" type="slidenum">
              <a:rPr/>
              <a:pPr lvl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37179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8"/>
          <p:cNvSpPr/>
          <p:nvPr/>
        </p:nvSpPr>
        <p:spPr>
          <a:xfrm>
            <a:off x="64008" y="69750"/>
            <a:ext cx="9013368" cy="6693407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solidFill>
            <a:srgbClr val="FFFFFF"/>
          </a:solid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1"/>
          <p:cNvSpPr txBox="1">
            <a:spLocks noGrp="1"/>
          </p:cNvSpPr>
          <p:nvPr>
            <p:ph type="title"/>
          </p:nvPr>
        </p:nvSpPr>
        <p:spPr>
          <a:xfrm>
            <a:off x="914400" y="273048"/>
            <a:ext cx="7772400" cy="1143000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2"/>
          <p:cNvSpPr txBox="1">
            <a:spLocks noGrp="1"/>
          </p:cNvSpPr>
          <p:nvPr>
            <p:ph type="body" idx="2"/>
          </p:nvPr>
        </p:nvSpPr>
        <p:spPr>
          <a:xfrm>
            <a:off x="914400" y="1600200"/>
            <a:ext cx="1904996" cy="4495803"/>
          </a:xfrm>
        </p:spPr>
        <p:txBody>
          <a:bodyPr/>
          <a:lstStyle>
            <a:lvl1pPr marL="0" indent="0">
              <a:buNone/>
              <a:defRPr sz="18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9DAA5AD-1C2C-486D-9CAD-7395A1E6D2BD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8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75EEFF6-E812-4D8B-A4B9-C917E2F842A5}" type="slidenum">
              <a:rPr/>
              <a:pPr lvl="0"/>
              <a:t>‹#›</a:t>
            </a:fld>
            <a:endParaRPr lang="de-DE"/>
          </a:p>
        </p:txBody>
      </p:sp>
      <p:sp>
        <p:nvSpPr>
          <p:cNvPr id="9" name="Content Placeholder 10"/>
          <p:cNvSpPr txBox="1">
            <a:spLocks noGrp="1"/>
          </p:cNvSpPr>
          <p:nvPr>
            <p:ph idx="1"/>
          </p:nvPr>
        </p:nvSpPr>
        <p:spPr>
          <a:xfrm>
            <a:off x="2971800" y="1600200"/>
            <a:ext cx="5715000" cy="449580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092500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914400" y="4900553"/>
            <a:ext cx="7315200" cy="522286"/>
          </a:xfrm>
        </p:spPr>
        <p:txBody>
          <a:bodyPr anchor="ctr"/>
          <a:lstStyle>
            <a:lvl1pPr>
              <a:defRPr sz="28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3"/>
          <p:cNvSpPr txBox="1">
            <a:spLocks noGrp="1"/>
          </p:cNvSpPr>
          <p:nvPr>
            <p:ph type="body" idx="2"/>
          </p:nvPr>
        </p:nvSpPr>
        <p:spPr>
          <a:xfrm>
            <a:off x="914400" y="5445828"/>
            <a:ext cx="7315200" cy="685800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9B525EE-84EC-4CEF-A8B2-81B0386111AC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5" name="Footer Placeholder 5"/>
          <p:cNvSpPr txBox="1">
            <a:spLocks noGrp="1"/>
          </p:cNvSpPr>
          <p:nvPr>
            <p:ph type="ftr" sz="quarter" idx="9"/>
          </p:nvPr>
        </p:nvSpPr>
        <p:spPr>
          <a:xfrm>
            <a:off x="914400" y="6172200"/>
            <a:ext cx="3886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6"/>
          <p:cNvSpPr txBox="1">
            <a:spLocks noGrp="1"/>
          </p:cNvSpPr>
          <p:nvPr>
            <p:ph type="sldNum" sz="quarter" idx="8"/>
          </p:nvPr>
        </p:nvSpPr>
        <p:spPr>
          <a:xfrm>
            <a:off x="146304" y="6208776"/>
            <a:ext cx="457200" cy="457200"/>
          </a:xfrm>
        </p:spPr>
        <p:txBody>
          <a:bodyPr/>
          <a:lstStyle>
            <a:lvl1pPr>
              <a:defRPr/>
            </a:lvl1pPr>
          </a:lstStyle>
          <a:p>
            <a:pPr lvl="0"/>
            <a:fld id="{61174793-849C-47D2-9E54-11ABA43941CE}" type="slidenum">
              <a:rPr/>
              <a:pPr lvl="0"/>
              <a:t>‹#›</a:t>
            </a:fld>
            <a:endParaRPr lang="de-DE"/>
          </a:p>
        </p:txBody>
      </p:sp>
      <p:sp>
        <p:nvSpPr>
          <p:cNvPr id="7" name="Rectangle 10"/>
          <p:cNvSpPr/>
          <p:nvPr/>
        </p:nvSpPr>
        <p:spPr>
          <a:xfrm flipV="1">
            <a:off x="68305" y="4683556"/>
            <a:ext cx="9006840" cy="91440"/>
          </a:xfrm>
          <a:prstGeom prst="rect">
            <a:avLst/>
          </a:prstGeom>
          <a:solidFill>
            <a:srgbClr val="D34817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8" name="Rectangle 11"/>
          <p:cNvSpPr/>
          <p:nvPr/>
        </p:nvSpPr>
        <p:spPr>
          <a:xfrm>
            <a:off x="68506" y="4650473"/>
            <a:ext cx="9006638" cy="45720"/>
          </a:xfrm>
          <a:prstGeom prst="rect">
            <a:avLst/>
          </a:prstGeom>
          <a:solidFill>
            <a:srgbClr val="E6B1AB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9" name="Rectangle 12"/>
          <p:cNvSpPr/>
          <p:nvPr/>
        </p:nvSpPr>
        <p:spPr>
          <a:xfrm>
            <a:off x="68506" y="4773222"/>
            <a:ext cx="9006638" cy="48810"/>
          </a:xfrm>
          <a:prstGeom prst="rect">
            <a:avLst/>
          </a:prstGeom>
          <a:solidFill>
            <a:srgbClr val="918485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10" name="Picture Placeholder 2"/>
          <p:cNvSpPr txBox="1">
            <a:spLocks noGrp="1"/>
          </p:cNvSpPr>
          <p:nvPr>
            <p:ph type="pic" idx="1"/>
          </p:nvPr>
        </p:nvSpPr>
        <p:spPr>
          <a:xfrm>
            <a:off x="68305" y="66678"/>
            <a:ext cx="9001874" cy="4581528"/>
          </a:xfrm>
          <a:solidFill>
            <a:srgbClr val="E9E5DC"/>
          </a:solidFill>
          <a:ln w="6345">
            <a:solidFill>
              <a:srgbClr val="000000"/>
            </a:solidFill>
            <a:prstDash val="solid"/>
          </a:ln>
        </p:spPr>
        <p:txBody>
          <a:bodyPr/>
          <a:lstStyle>
            <a:lvl1pPr marL="0" indent="0">
              <a:buNone/>
              <a:defRPr sz="3200"/>
            </a:lvl1pPr>
          </a:lstStyle>
          <a:p>
            <a:pPr lvl="0"/>
            <a:r>
              <a:rPr lang="en-US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30482912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8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>
            <a:noFill/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3" name="Rounded Rectangle 7"/>
          <p:cNvSpPr/>
          <p:nvPr/>
        </p:nvSpPr>
        <p:spPr>
          <a:xfrm>
            <a:off x="64008" y="69750"/>
            <a:ext cx="9013368" cy="6693407"/>
          </a:xfrm>
          <a:custGeom>
            <a:avLst/>
            <a:gdLst>
              <a:gd name="f0" fmla="val 10800000"/>
              <a:gd name="f1" fmla="val 5400000"/>
              <a:gd name="f2" fmla="val 16200000"/>
              <a:gd name="f3" fmla="val w"/>
              <a:gd name="f4" fmla="val h"/>
              <a:gd name="f5" fmla="val ss"/>
              <a:gd name="f6" fmla="val 0"/>
              <a:gd name="f7" fmla="*/ 5419351 1 1725033"/>
              <a:gd name="f8" fmla="val 45"/>
              <a:gd name="f9" fmla="val 1065"/>
              <a:gd name="f10" fmla="abs f3"/>
              <a:gd name="f11" fmla="abs f4"/>
              <a:gd name="f12" fmla="abs f5"/>
              <a:gd name="f13" fmla="*/ f7 1 180"/>
              <a:gd name="f14" fmla="+- 0 0 f1"/>
              <a:gd name="f15" fmla="+- f6 f9 0"/>
              <a:gd name="f16" fmla="?: f10 f3 1"/>
              <a:gd name="f17" fmla="?: f11 f4 1"/>
              <a:gd name="f18" fmla="?: f12 f5 1"/>
              <a:gd name="f19" fmla="*/ f8 f13 1"/>
              <a:gd name="f20" fmla="+- f6 0 f15"/>
              <a:gd name="f21" fmla="+- f15 0 f6"/>
              <a:gd name="f22" fmla="*/ f16 1 21600"/>
              <a:gd name="f23" fmla="*/ f17 1 21600"/>
              <a:gd name="f24" fmla="*/ 21600 f16 1"/>
              <a:gd name="f25" fmla="*/ 21600 f17 1"/>
              <a:gd name="f26" fmla="+- 0 0 f19"/>
              <a:gd name="f27" fmla="abs f20"/>
              <a:gd name="f28" fmla="abs f21"/>
              <a:gd name="f29" fmla="?: f20 f14 f1"/>
              <a:gd name="f30" fmla="?: f20 f1 f14"/>
              <a:gd name="f31" fmla="?: f20 f2 f1"/>
              <a:gd name="f32" fmla="?: f20 f1 f2"/>
              <a:gd name="f33" fmla="?: f21 f14 f1"/>
              <a:gd name="f34" fmla="?: f21 f1 f14"/>
              <a:gd name="f35" fmla="?: f20 0 f0"/>
              <a:gd name="f36" fmla="?: f20 f0 0"/>
              <a:gd name="f37" fmla="min f23 f22"/>
              <a:gd name="f38" fmla="*/ f24 1 f18"/>
              <a:gd name="f39" fmla="*/ f25 1 f18"/>
              <a:gd name="f40" fmla="*/ f26 f0 1"/>
              <a:gd name="f41" fmla="?: f20 f32 f31"/>
              <a:gd name="f42" fmla="?: f20 f31 f32"/>
              <a:gd name="f43" fmla="?: f21 f30 f29"/>
              <a:gd name="f44" fmla="val f38"/>
              <a:gd name="f45" fmla="val f39"/>
              <a:gd name="f46" fmla="*/ f40 1 f7"/>
              <a:gd name="f47" fmla="?: f21 f42 f41"/>
              <a:gd name="f48" fmla="*/ f15 f37 1"/>
              <a:gd name="f49" fmla="*/ f6 f37 1"/>
              <a:gd name="f50" fmla="*/ f27 f37 1"/>
              <a:gd name="f51" fmla="*/ f28 f37 1"/>
              <a:gd name="f52" fmla="+- f45 0 f9"/>
              <a:gd name="f53" fmla="+- f44 0 f9"/>
              <a:gd name="f54" fmla="+- f46 0 f1"/>
              <a:gd name="f55" fmla="*/ f45 f37 1"/>
              <a:gd name="f56" fmla="*/ f44 f37 1"/>
              <a:gd name="f57" fmla="+- f45 0 f52"/>
              <a:gd name="f58" fmla="+- f44 0 f53"/>
              <a:gd name="f59" fmla="+- f52 0 f45"/>
              <a:gd name="f60" fmla="+- f53 0 f44"/>
              <a:gd name="f61" fmla="+- f54 f1 0"/>
              <a:gd name="f62" fmla="*/ f52 f37 1"/>
              <a:gd name="f63" fmla="*/ f53 f37 1"/>
              <a:gd name="f64" fmla="abs f57"/>
              <a:gd name="f65" fmla="?: f57 0 f0"/>
              <a:gd name="f66" fmla="?: f57 f0 0"/>
              <a:gd name="f67" fmla="?: f57 f33 f34"/>
              <a:gd name="f68" fmla="abs f58"/>
              <a:gd name="f69" fmla="abs f59"/>
              <a:gd name="f70" fmla="?: f58 f14 f1"/>
              <a:gd name="f71" fmla="?: f58 f1 f14"/>
              <a:gd name="f72" fmla="?: f58 f2 f1"/>
              <a:gd name="f73" fmla="?: f58 f1 f2"/>
              <a:gd name="f74" fmla="abs f60"/>
              <a:gd name="f75" fmla="?: f60 f14 f1"/>
              <a:gd name="f76" fmla="?: f60 f1 f14"/>
              <a:gd name="f77" fmla="?: f60 f36 f35"/>
              <a:gd name="f78" fmla="?: f60 f35 f36"/>
              <a:gd name="f79" fmla="*/ f61 f7 1"/>
              <a:gd name="f80" fmla="?: f21 f66 f65"/>
              <a:gd name="f81" fmla="?: f21 f65 f66"/>
              <a:gd name="f82" fmla="?: f58 f73 f72"/>
              <a:gd name="f83" fmla="?: f58 f72 f73"/>
              <a:gd name="f84" fmla="?: f59 f71 f70"/>
              <a:gd name="f85" fmla="?: f20 f77 f78"/>
              <a:gd name="f86" fmla="?: f20 f75 f76"/>
              <a:gd name="f87" fmla="*/ f79 1 f0"/>
              <a:gd name="f88" fmla="*/ f64 f37 1"/>
              <a:gd name="f89" fmla="*/ f68 f37 1"/>
              <a:gd name="f90" fmla="*/ f69 f37 1"/>
              <a:gd name="f91" fmla="*/ f74 f37 1"/>
              <a:gd name="f92" fmla="?: f57 f80 f81"/>
              <a:gd name="f93" fmla="?: f59 f83 f82"/>
              <a:gd name="f94" fmla="+- 0 0 f87"/>
              <a:gd name="f95" fmla="+- 0 0 f94"/>
              <a:gd name="f96" fmla="*/ f95 f0 1"/>
              <a:gd name="f97" fmla="*/ f96 1 f7"/>
              <a:gd name="f98" fmla="+- f97 0 f1"/>
              <a:gd name="f99" fmla="cos 1 f98"/>
              <a:gd name="f100" fmla="+- 0 0 f99"/>
              <a:gd name="f101" fmla="+- 0 0 f100"/>
              <a:gd name="f102" fmla="val f101"/>
              <a:gd name="f103" fmla="+- 0 0 f102"/>
              <a:gd name="f104" fmla="*/ f9 f103 1"/>
              <a:gd name="f105" fmla="*/ f104 3163 1"/>
              <a:gd name="f106" fmla="*/ f105 1 7636"/>
              <a:gd name="f107" fmla="+- f6 f106 0"/>
              <a:gd name="f108" fmla="+- f44 0 f106"/>
              <a:gd name="f109" fmla="+- f45 0 f106"/>
              <a:gd name="f110" fmla="*/ f107 f37 1"/>
              <a:gd name="f111" fmla="*/ f108 f37 1"/>
              <a:gd name="f112" fmla="*/ f109 f37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10" t="f110" r="f111" b="f112"/>
            <a:pathLst>
              <a:path>
                <a:moveTo>
                  <a:pt x="f48" y="f49"/>
                </a:moveTo>
                <a:arcTo wR="f50" hR="f51" stAng="f47" swAng="f43"/>
                <a:lnTo>
                  <a:pt x="f49" y="f62"/>
                </a:lnTo>
                <a:arcTo wR="f51" hR="f88" stAng="f92" swAng="f67"/>
                <a:lnTo>
                  <a:pt x="f63" y="f55"/>
                </a:lnTo>
                <a:arcTo wR="f89" hR="f90" stAng="f93" swAng="f84"/>
                <a:lnTo>
                  <a:pt x="f56" y="f48"/>
                </a:lnTo>
                <a:arcTo wR="f91" hR="f50" stAng="f85" swAng="f86"/>
                <a:close/>
              </a:path>
            </a:pathLst>
          </a:custGeom>
          <a:solidFill>
            <a:srgbClr val="FFFFFF"/>
          </a:solidFill>
          <a:ln w="6345">
            <a:solidFill>
              <a:srgbClr val="000000"/>
            </a:solidFill>
            <a:prstDash val="solid"/>
          </a:ln>
        </p:spPr>
        <p:txBody>
          <a:bodyPr vert="horz" wrap="square" lIns="91440" tIns="45720" rIns="91440" bIns="45720" anchor="ctr" anchorCtr="1" compatLnSpc="1"/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US" sz="1800" b="0" i="0" u="none" strike="noStrike" kern="1200" cap="none" spc="0" baseline="0">
              <a:solidFill>
                <a:srgbClr val="FFFFFF"/>
              </a:solidFill>
              <a:uFillTx/>
              <a:latin typeface="Perpetua"/>
            </a:endParaRPr>
          </a:p>
        </p:txBody>
      </p:sp>
      <p:sp>
        <p:nvSpPr>
          <p:cNvPr id="4" name="Title Placeholder 21"/>
          <p:cNvSpPr txBox="1">
            <a:spLocks noGrp="1"/>
          </p:cNvSpPr>
          <p:nvPr>
            <p:ph type="title"/>
          </p:nvPr>
        </p:nvSpPr>
        <p:spPr>
          <a:xfrm>
            <a:off x="914400" y="274640"/>
            <a:ext cx="7772400" cy="11430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91440" anchor="b" anchorCtr="0" compatLnSpc="1"/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" name="Text Placeholder 12"/>
          <p:cNvSpPr txBox="1">
            <a:spLocks noGrp="1"/>
          </p:cNvSpPr>
          <p:nvPr>
            <p:ph type="body" idx="1"/>
          </p:nvPr>
        </p:nvSpPr>
        <p:spPr>
          <a:xfrm>
            <a:off x="914400" y="1447796"/>
            <a:ext cx="7772400" cy="45720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Date Placeholder 13"/>
          <p:cNvSpPr txBox="1">
            <a:spLocks noGrp="1"/>
          </p:cNvSpPr>
          <p:nvPr>
            <p:ph type="dt" sz="half" idx="2"/>
          </p:nvPr>
        </p:nvSpPr>
        <p:spPr>
          <a:xfrm>
            <a:off x="6172200" y="6191246"/>
            <a:ext cx="2476496" cy="47624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696464"/>
                </a:solidFill>
                <a:uFillTx/>
                <a:latin typeface="Perpetua"/>
              </a:defRPr>
            </a:lvl1pPr>
          </a:lstStyle>
          <a:p>
            <a:pPr lvl="0"/>
            <a:fld id="{B7C87843-29A8-4B27-9A56-528D4759A020}" type="datetime1">
              <a:rPr lang="de-DE"/>
              <a:pPr lvl="0"/>
              <a:t>21.01.2017</a:t>
            </a:fld>
            <a:endParaRPr lang="de-DE"/>
          </a:p>
        </p:txBody>
      </p:sp>
      <p:sp>
        <p:nvSpPr>
          <p:cNvPr id="7" name="Footer Placeholder 2"/>
          <p:cNvSpPr txBox="1">
            <a:spLocks noGrp="1"/>
          </p:cNvSpPr>
          <p:nvPr>
            <p:ph type="ftr" sz="quarter" idx="3"/>
          </p:nvPr>
        </p:nvSpPr>
        <p:spPr>
          <a:xfrm>
            <a:off x="914400" y="6172200"/>
            <a:ext cx="3962396" cy="4572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/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696464"/>
                </a:solidFill>
                <a:uFillTx/>
                <a:latin typeface="Perpetua"/>
              </a:defRPr>
            </a:lvl1pPr>
          </a:lstStyle>
          <a:p>
            <a:pPr lvl="0"/>
            <a:endParaRPr lang="de-DE"/>
          </a:p>
        </p:txBody>
      </p:sp>
      <p:sp>
        <p:nvSpPr>
          <p:cNvPr id="8" name="Slide Number Placeholder 22"/>
          <p:cNvSpPr txBox="1">
            <a:spLocks noGrp="1"/>
          </p:cNvSpPr>
          <p:nvPr>
            <p:ph type="sldNum" sz="quarter" idx="4"/>
          </p:nvPr>
        </p:nvSpPr>
        <p:spPr>
          <a:xfrm>
            <a:off x="146304" y="6210303"/>
            <a:ext cx="457200" cy="457200"/>
          </a:xfrm>
          <a:prstGeom prst="rect">
            <a:avLst/>
          </a:prstGeom>
          <a:solidFill>
            <a:srgbClr val="D34817"/>
          </a:solidFill>
          <a:ln>
            <a:noFill/>
          </a:ln>
        </p:spPr>
        <p:txBody>
          <a:bodyPr vert="horz" wrap="none" lIns="0" tIns="0" rIns="0" bIns="0" anchor="ctr" anchorCtr="1" compatLnSpc="1"/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400" b="0" i="0" u="none" strike="noStrike" kern="1200" cap="none" spc="0" baseline="0">
                <a:solidFill>
                  <a:srgbClr val="FFFFFF"/>
                </a:solidFill>
                <a:uFillTx/>
                <a:latin typeface="Franklin Gothic Book"/>
              </a:defRPr>
            </a:lvl1pPr>
          </a:lstStyle>
          <a:p>
            <a:pPr lvl="0"/>
            <a:fld id="{32BDC93F-0C38-439E-9C7B-0A2D23B61AB3}" type="slidenum">
              <a:rPr/>
              <a:pPr lvl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marL="0" marR="0" lvl="0" indent="0" algn="l" defTabSz="914400" rtl="0" fontAlgn="auto" hangingPunct="1">
        <a:lnSpc>
          <a:spcPct val="100000"/>
        </a:lnSpc>
        <a:spcBef>
          <a:spcPts val="0"/>
        </a:spcBef>
        <a:spcAft>
          <a:spcPts val="0"/>
        </a:spcAft>
        <a:buNone/>
        <a:tabLst/>
        <a:defRPr lang="en-US" sz="4000" b="0" i="0" u="none" strike="noStrike" kern="1200" cap="none" spc="0" baseline="0">
          <a:solidFill>
            <a:srgbClr val="696464"/>
          </a:solidFill>
          <a:uFillTx/>
          <a:latin typeface="Franklin Gothic Book"/>
        </a:defRPr>
      </a:lvl1pPr>
    </p:titleStyle>
    <p:bodyStyle>
      <a:lvl1pPr marL="274320" marR="0" lvl="0" indent="-274320" algn="l" defTabSz="914400" rtl="0" fontAlgn="auto" hangingPunct="1">
        <a:lnSpc>
          <a:spcPct val="100000"/>
        </a:lnSpc>
        <a:spcBef>
          <a:spcPts val="580"/>
        </a:spcBef>
        <a:spcAft>
          <a:spcPts val="0"/>
        </a:spcAft>
        <a:buClr>
          <a:srgbClr val="D34817"/>
        </a:buClr>
        <a:buSzPct val="85000"/>
        <a:buFont typeface="Wingdings 2"/>
        <a:buChar char=""/>
        <a:tabLst/>
        <a:defRPr lang="en-US" sz="2600" b="0" i="0" u="none" strike="noStrike" kern="1200" cap="none" spc="0" baseline="0">
          <a:solidFill>
            <a:srgbClr val="000000"/>
          </a:solidFill>
          <a:uFillTx/>
          <a:latin typeface="Perpetua"/>
        </a:defRPr>
      </a:lvl1pPr>
      <a:lvl2pPr marL="548640" marR="0" lvl="1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9B2D1F"/>
        </a:buClr>
        <a:buSzPct val="85000"/>
        <a:buFont typeface="Wingdings 2"/>
        <a:buChar char="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Perpetua"/>
        </a:defRPr>
      </a:lvl2pPr>
      <a:lvl3pPr marL="822960" marR="0" lvl="2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E6B1AB"/>
        </a:buClr>
        <a:buSzPct val="85000"/>
        <a:buFont typeface="Wingdings 2"/>
        <a:buChar char="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3pPr>
      <a:lvl4pPr marL="1097280" marR="0" lvl="3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A28E6A"/>
        </a:buClr>
        <a:buSzPct val="80000"/>
        <a:buFont typeface="Wingdings 2"/>
        <a:buChar char="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4pPr>
      <a:lvl5pPr marL="1371600" marR="0" lvl="4" indent="-228600" algn="l" defTabSz="914400" rtl="0" fontAlgn="auto" hangingPunct="1">
        <a:lnSpc>
          <a:spcPct val="100000"/>
        </a:lnSpc>
        <a:spcBef>
          <a:spcPts val="370"/>
        </a:spcBef>
        <a:spcAft>
          <a:spcPts val="0"/>
        </a:spcAft>
        <a:buClr>
          <a:srgbClr val="A28E6A"/>
        </a:buClr>
        <a:buSzPct val="100000"/>
        <a:buChar char="o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Perpetua"/>
        </a:defRPr>
      </a:lvl5pPr>
    </p:bodyStyle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/>
          <p:cNvSpPr/>
          <p:nvPr/>
        </p:nvSpPr>
        <p:spPr>
          <a:xfrm>
            <a:off x="417577" y="2902332"/>
            <a:ext cx="2409760" cy="1947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3" name="Group 2"/>
          <p:cNvGrpSpPr/>
          <p:nvPr/>
        </p:nvGrpSpPr>
        <p:grpSpPr>
          <a:xfrm>
            <a:off x="908795" y="353837"/>
            <a:ext cx="3032004" cy="2861349"/>
            <a:chOff x="80753" y="819482"/>
            <a:chExt cx="2957868" cy="2669977"/>
          </a:xfrm>
        </p:grpSpPr>
        <p:pic>
          <p:nvPicPr>
            <p:cNvPr id="28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7177" y="819482"/>
              <a:ext cx="2301444" cy="24327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0" name="TextBox 49"/>
            <p:cNvSpPr txBox="1"/>
            <p:nvPr/>
          </p:nvSpPr>
          <p:spPr>
            <a:xfrm>
              <a:off x="80753" y="1728064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CD8</a:t>
              </a:r>
              <a:endParaRPr lang="de-DE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676400" y="3181682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CD4</a:t>
              </a:r>
              <a:endParaRPr lang="de-DE" sz="1400" dirty="0"/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3955193" y="4353"/>
            <a:ext cx="78380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00" dirty="0" smtClean="0"/>
              <a:t>Tregs</a:t>
            </a:r>
            <a:endParaRPr lang="de-DE" sz="2200" dirty="0"/>
          </a:p>
        </p:txBody>
      </p:sp>
      <p:sp>
        <p:nvSpPr>
          <p:cNvPr id="38" name="Rectangle 37"/>
          <p:cNvSpPr/>
          <p:nvPr/>
        </p:nvSpPr>
        <p:spPr>
          <a:xfrm rot="16200000">
            <a:off x="-313630" y="4623502"/>
            <a:ext cx="1826145" cy="904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" name="Rectangle 38"/>
          <p:cNvSpPr/>
          <p:nvPr/>
        </p:nvSpPr>
        <p:spPr>
          <a:xfrm rot="16200000">
            <a:off x="1779521" y="4556610"/>
            <a:ext cx="1826145" cy="1651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Rectangle 39"/>
          <p:cNvSpPr/>
          <p:nvPr/>
        </p:nvSpPr>
        <p:spPr>
          <a:xfrm rot="16200000">
            <a:off x="4119140" y="4503917"/>
            <a:ext cx="1826145" cy="904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tangle 40"/>
          <p:cNvSpPr/>
          <p:nvPr/>
        </p:nvSpPr>
        <p:spPr>
          <a:xfrm>
            <a:off x="2914812" y="5687837"/>
            <a:ext cx="1824185" cy="1975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2" name="Rectangle 41"/>
          <p:cNvSpPr/>
          <p:nvPr/>
        </p:nvSpPr>
        <p:spPr>
          <a:xfrm>
            <a:off x="832589" y="5718891"/>
            <a:ext cx="1824185" cy="1975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Rectangle 42"/>
          <p:cNvSpPr/>
          <p:nvPr/>
        </p:nvSpPr>
        <p:spPr>
          <a:xfrm>
            <a:off x="5077437" y="5668896"/>
            <a:ext cx="1824185" cy="1975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13" name="Group 12"/>
          <p:cNvGrpSpPr/>
          <p:nvPr/>
        </p:nvGrpSpPr>
        <p:grpSpPr>
          <a:xfrm>
            <a:off x="390053" y="3636068"/>
            <a:ext cx="2266721" cy="2583269"/>
            <a:chOff x="247879" y="3665131"/>
            <a:chExt cx="2266721" cy="2583269"/>
          </a:xfrm>
        </p:grpSpPr>
        <p:pic>
          <p:nvPicPr>
            <p:cNvPr id="29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738" y="3665131"/>
              <a:ext cx="2077862" cy="23546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8" name="TextBox 57"/>
            <p:cNvSpPr txBox="1"/>
            <p:nvPr/>
          </p:nvSpPr>
          <p:spPr>
            <a:xfrm rot="16200000">
              <a:off x="92805" y="4386641"/>
              <a:ext cx="6179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FoxP3</a:t>
              </a:r>
              <a:endParaRPr lang="de-DE" sz="14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219200" y="5940623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CD25</a:t>
              </a:r>
              <a:endParaRPr lang="de-DE" sz="14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061402" y="3636068"/>
            <a:ext cx="2255535" cy="2583269"/>
            <a:chOff x="2424147" y="3665131"/>
            <a:chExt cx="2255535" cy="2583269"/>
          </a:xfrm>
        </p:grpSpPr>
        <p:pic>
          <p:nvPicPr>
            <p:cNvPr id="30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4600" y="3665131"/>
              <a:ext cx="2165082" cy="23546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3" name="TextBox 62"/>
            <p:cNvSpPr txBox="1"/>
            <p:nvPr/>
          </p:nvSpPr>
          <p:spPr>
            <a:xfrm rot="16200000">
              <a:off x="2260481" y="4484349"/>
              <a:ext cx="635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Helios</a:t>
              </a:r>
              <a:endParaRPr lang="de-DE" sz="14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199214" y="5940623"/>
              <a:ext cx="6551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FOXP3</a:t>
              </a:r>
              <a:endParaRPr lang="de-DE" sz="1400" dirty="0"/>
            </a:p>
          </p:txBody>
        </p:sp>
      </p:grpSp>
      <p:sp>
        <p:nvSpPr>
          <p:cNvPr id="45" name="Rectangle 44"/>
          <p:cNvSpPr/>
          <p:nvPr/>
        </p:nvSpPr>
        <p:spPr>
          <a:xfrm>
            <a:off x="4210212" y="2945340"/>
            <a:ext cx="3539873" cy="1859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6" name="Group 5"/>
          <p:cNvGrpSpPr/>
          <p:nvPr/>
        </p:nvGrpSpPr>
        <p:grpSpPr>
          <a:xfrm>
            <a:off x="4527026" y="421707"/>
            <a:ext cx="2646150" cy="2600837"/>
            <a:chOff x="3097177" y="809987"/>
            <a:chExt cx="2646150" cy="2600837"/>
          </a:xfrm>
        </p:grpSpPr>
        <p:pic>
          <p:nvPicPr>
            <p:cNvPr id="34" name="Picture 8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809987"/>
              <a:ext cx="2314327" cy="24327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3" name="TextBox 52"/>
            <p:cNvSpPr txBox="1"/>
            <p:nvPr/>
          </p:nvSpPr>
          <p:spPr>
            <a:xfrm rot="16200000">
              <a:off x="2920340" y="1872457"/>
              <a:ext cx="66145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400" dirty="0" smtClean="0"/>
                <a:t> FoxP3</a:t>
              </a:r>
              <a:endParaRPr lang="de-DE" sz="14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44751" y="3103047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CD8</a:t>
              </a:r>
              <a:endParaRPr lang="de-DE" sz="14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751636" y="3225564"/>
            <a:ext cx="2299972" cy="2659819"/>
            <a:chOff x="5715000" y="753890"/>
            <a:chExt cx="2299972" cy="2659819"/>
          </a:xfrm>
        </p:grpSpPr>
        <p:pic>
          <p:nvPicPr>
            <p:cNvPr id="31" name="Picture 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0794" y="753890"/>
              <a:ext cx="2004178" cy="23877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TextBox 61"/>
            <p:cNvSpPr txBox="1"/>
            <p:nvPr/>
          </p:nvSpPr>
          <p:spPr>
            <a:xfrm rot="16200000">
              <a:off x="4823241" y="1806157"/>
              <a:ext cx="209129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400" dirty="0" smtClean="0"/>
                <a:t>                     FoxP3</a:t>
              </a:r>
              <a:endParaRPr lang="de-DE" sz="14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771471" y="3105932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CD4</a:t>
              </a:r>
              <a:endParaRPr lang="de-DE" sz="1400" dirty="0"/>
            </a:p>
          </p:txBody>
        </p:sp>
      </p:grpSp>
      <p:cxnSp>
        <p:nvCxnSpPr>
          <p:cNvPr id="15" name="Straight Arrow Connector 14"/>
          <p:cNvCxnSpPr/>
          <p:nvPr/>
        </p:nvCxnSpPr>
        <p:spPr>
          <a:xfrm>
            <a:off x="3940799" y="1492460"/>
            <a:ext cx="406296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4210212" y="2714767"/>
            <a:ext cx="1295400" cy="510797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676812" y="3021540"/>
            <a:ext cx="0" cy="380297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2229012" y="2999684"/>
            <a:ext cx="0" cy="386387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1742442" y="6324600"/>
            <a:ext cx="7858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dditional File </a:t>
            </a:r>
            <a:r>
              <a:rPr lang="de-DE" sz="1200" dirty="0" smtClean="0"/>
              <a:t>3. Gating strategy used to identify regulatory </a:t>
            </a:r>
            <a:r>
              <a:rPr lang="de-DE" sz="1200" smtClean="0"/>
              <a:t>T </a:t>
            </a:r>
            <a:r>
              <a:rPr lang="de-DE" sz="1200" smtClean="0"/>
              <a:t>cells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423803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quity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quity</Template>
  <TotalTime>49</TotalTime>
  <Words>27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Equity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TI Group Seminar</dc:title>
  <dc:creator>Jithendra</dc:creator>
  <cp:lastModifiedBy>Christopher Shipp</cp:lastModifiedBy>
  <cp:revision>144</cp:revision>
  <dcterms:created xsi:type="dcterms:W3CDTF">2013-02-19T11:11:27Z</dcterms:created>
  <dcterms:modified xsi:type="dcterms:W3CDTF">2017-01-21T15:25:44Z</dcterms:modified>
</cp:coreProperties>
</file>